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1128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ctive%20constituents%20in%20MPs%20Uttarakhand\Data%20Active%20compounds\Phytochemical%20final%20data\Graph%20&amp;%20tables%20phytochemica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ctive%20constituents%20in%20MPs%20Uttarakhand\Data%20Active%20compounds\Phytochemical%20final%20data\Graph%20&amp;%20tables%20phytochemic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pieChart>
        <c:varyColors val="1"/>
        <c:ser>
          <c:idx val="0"/>
          <c:order val="0"/>
          <c:spPr>
            <a:effectLst>
              <a:innerShdw blurRad="63500" dist="50800" dir="13500000">
                <a:prstClr val="black">
                  <a:alpha val="50000"/>
                </a:prstClr>
              </a:innerShdw>
            </a:effectLst>
          </c:spPr>
          <c:dLbls>
            <c:dLbl>
              <c:idx val="26"/>
              <c:tx>
                <c:rich>
                  <a:bodyPr/>
                  <a:lstStyle/>
                  <a:p>
                    <a:r>
                      <a:rPr lang="en-US" sz="600"/>
                      <a:t>25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44C6-4959-ABC9-ABC79C663AA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sz="6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different family (taxo, &amp; chem.'!$E$2:$E$28</c:f>
              <c:strCache>
                <c:ptCount val="27"/>
                <c:pt idx="0">
                  <c:v>Asteraceae</c:v>
                </c:pt>
                <c:pt idx="1">
                  <c:v>Lamiaceae  </c:v>
                </c:pt>
                <c:pt idx="2">
                  <c:v>Fabaceae</c:v>
                </c:pt>
                <c:pt idx="3">
                  <c:v>Rosaceae</c:v>
                </c:pt>
                <c:pt idx="4">
                  <c:v>Ranunculaceae</c:v>
                </c:pt>
                <c:pt idx="5">
                  <c:v>Orchidaceae</c:v>
                </c:pt>
                <c:pt idx="6">
                  <c:v>Euphorbiaceae</c:v>
                </c:pt>
                <c:pt idx="7">
                  <c:v>Solanaceae</c:v>
                </c:pt>
                <c:pt idx="8">
                  <c:v>Poaceae</c:v>
                </c:pt>
                <c:pt idx="9">
                  <c:v>Polygonaceae</c:v>
                </c:pt>
                <c:pt idx="10">
                  <c:v>Malvaceae</c:v>
                </c:pt>
                <c:pt idx="11">
                  <c:v>Apiaceae</c:v>
                </c:pt>
                <c:pt idx="12">
                  <c:v>Acanthaceae</c:v>
                </c:pt>
                <c:pt idx="13">
                  <c:v>Apocynaceae</c:v>
                </c:pt>
                <c:pt idx="14">
                  <c:v>Scorphulariaceae</c:v>
                </c:pt>
                <c:pt idx="15">
                  <c:v>Verbanaceae</c:v>
                </c:pt>
                <c:pt idx="16">
                  <c:v>Amaranthaceae</c:v>
                </c:pt>
                <c:pt idx="17">
                  <c:v>Rubiaceae</c:v>
                </c:pt>
                <c:pt idx="18">
                  <c:v>Apocynaceae</c:v>
                </c:pt>
                <c:pt idx="19">
                  <c:v>Orobanchaceae</c:v>
                </c:pt>
                <c:pt idx="20">
                  <c:v>Liliaceae</c:v>
                </c:pt>
                <c:pt idx="21">
                  <c:v>Moraceae</c:v>
                </c:pt>
                <c:pt idx="22">
                  <c:v>Papaveraceae</c:v>
                </c:pt>
                <c:pt idx="23">
                  <c:v>Boraginaceae</c:v>
                </c:pt>
                <c:pt idx="24">
                  <c:v>Cucurbitaceae</c:v>
                </c:pt>
                <c:pt idx="25">
                  <c:v>Rutaceae</c:v>
                </c:pt>
                <c:pt idx="26">
                  <c:v>Others</c:v>
                </c:pt>
              </c:strCache>
            </c:strRef>
          </c:cat>
          <c:val>
            <c:numRef>
              <c:f>'different family (taxo, &amp; chem.'!$F$2:$F$28</c:f>
              <c:numCache>
                <c:formatCode>General</c:formatCode>
                <c:ptCount val="27"/>
                <c:pt idx="0">
                  <c:v>65</c:v>
                </c:pt>
                <c:pt idx="1">
                  <c:v>59</c:v>
                </c:pt>
                <c:pt idx="2">
                  <c:v>54</c:v>
                </c:pt>
                <c:pt idx="3">
                  <c:v>34</c:v>
                </c:pt>
                <c:pt idx="4">
                  <c:v>24</c:v>
                </c:pt>
                <c:pt idx="5">
                  <c:v>22</c:v>
                </c:pt>
                <c:pt idx="6">
                  <c:v>20</c:v>
                </c:pt>
                <c:pt idx="7">
                  <c:v>20</c:v>
                </c:pt>
                <c:pt idx="8">
                  <c:v>17</c:v>
                </c:pt>
                <c:pt idx="9">
                  <c:v>17</c:v>
                </c:pt>
                <c:pt idx="10">
                  <c:v>17</c:v>
                </c:pt>
                <c:pt idx="11">
                  <c:v>16</c:v>
                </c:pt>
                <c:pt idx="12">
                  <c:v>15</c:v>
                </c:pt>
                <c:pt idx="13">
                  <c:v>15</c:v>
                </c:pt>
                <c:pt idx="14">
                  <c:v>13</c:v>
                </c:pt>
                <c:pt idx="15">
                  <c:v>13</c:v>
                </c:pt>
                <c:pt idx="16">
                  <c:v>13</c:v>
                </c:pt>
                <c:pt idx="17">
                  <c:v>12</c:v>
                </c:pt>
                <c:pt idx="18">
                  <c:v>12</c:v>
                </c:pt>
                <c:pt idx="19">
                  <c:v>12</c:v>
                </c:pt>
                <c:pt idx="20">
                  <c:v>11</c:v>
                </c:pt>
                <c:pt idx="21">
                  <c:v>11</c:v>
                </c:pt>
                <c:pt idx="22">
                  <c:v>11</c:v>
                </c:pt>
                <c:pt idx="23">
                  <c:v>10</c:v>
                </c:pt>
                <c:pt idx="24">
                  <c:v>10</c:v>
                </c:pt>
                <c:pt idx="25">
                  <c:v>10</c:v>
                </c:pt>
                <c:pt idx="26">
                  <c:v>2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4C6-4959-ABC9-ABC79C663A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73344575678040647"/>
          <c:y val="1.6607963086445281E-2"/>
          <c:w val="0.24740209223237436"/>
          <c:h val="0.98339191976002949"/>
        </c:manualLayout>
      </c:layout>
      <c:overlay val="0"/>
      <c:txPr>
        <a:bodyPr/>
        <a:lstStyle/>
        <a:p>
          <a:pPr>
            <a:defRPr lang="en-US" sz="11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zero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pieChart>
        <c:varyColors val="1"/>
        <c:ser>
          <c:idx val="0"/>
          <c:order val="0"/>
          <c:spPr>
            <a:effectLst>
              <a:innerShdw blurRad="63500" dist="50800" dir="13500000">
                <a:prstClr val="black">
                  <a:alpha val="50000"/>
                </a:prstClr>
              </a:innerShdw>
            </a:effectLst>
          </c:spPr>
          <c:dPt>
            <c:idx val="0"/>
            <c:bubble3D val="0"/>
            <c:spPr>
              <a:solidFill>
                <a:srgbClr val="0070C0"/>
              </a:solidFill>
              <a:effectLst>
                <a:innerShdw blurRad="63500" dist="50800" dir="13500000">
                  <a:prstClr val="black">
                    <a:alpha val="50000"/>
                  </a:prstClr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0-C945-4476-B033-6A032B90ACD3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effectLst>
                <a:innerShdw blurRad="63500" dist="50800" dir="13500000">
                  <a:prstClr val="black">
                    <a:alpha val="50000"/>
                  </a:prstClr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1-C945-4476-B033-6A032B90ACD3}"/>
              </c:ext>
            </c:extLst>
          </c:dPt>
          <c:dPt>
            <c:idx val="2"/>
            <c:bubble3D val="0"/>
            <c:spPr>
              <a:solidFill>
                <a:srgbClr val="00B050"/>
              </a:solidFill>
              <a:effectLst>
                <a:innerShdw blurRad="63500" dist="50800" dir="13500000">
                  <a:prstClr val="black">
                    <a:alpha val="50000"/>
                  </a:prstClr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2-C945-4476-B033-6A032B90ACD3}"/>
              </c:ext>
            </c:extLst>
          </c:dPt>
          <c:dPt>
            <c:idx val="4"/>
            <c:bubble3D val="0"/>
            <c:spPr>
              <a:solidFill>
                <a:srgbClr val="00B0F0"/>
              </a:solidFill>
              <a:effectLst>
                <a:innerShdw blurRad="63500" dist="50800" dir="13500000">
                  <a:prstClr val="black">
                    <a:alpha val="50000"/>
                  </a:prstClr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3-C945-4476-B033-6A032B90ACD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sz="600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Diversity, use value, diseases '!$A$10:$A$15</c:f>
              <c:strCache>
                <c:ptCount val="6"/>
                <c:pt idx="0">
                  <c:v>Herb</c:v>
                </c:pt>
                <c:pt idx="1">
                  <c:v>Shurb</c:v>
                </c:pt>
                <c:pt idx="2">
                  <c:v>Tree</c:v>
                </c:pt>
                <c:pt idx="3">
                  <c:v>Fern</c:v>
                </c:pt>
                <c:pt idx="4">
                  <c:v>Climber</c:v>
                </c:pt>
                <c:pt idx="5">
                  <c:v>Others</c:v>
                </c:pt>
              </c:strCache>
            </c:strRef>
          </c:cat>
          <c:val>
            <c:numRef>
              <c:f>'Diversity, use value, diseases '!$B$10:$B$15</c:f>
              <c:numCache>
                <c:formatCode>0.00%</c:formatCode>
                <c:ptCount val="6"/>
                <c:pt idx="0">
                  <c:v>0.58860000000000001</c:v>
                </c:pt>
                <c:pt idx="1">
                  <c:v>0.18237999999999999</c:v>
                </c:pt>
                <c:pt idx="2">
                  <c:v>0.17480000000000001</c:v>
                </c:pt>
                <c:pt idx="3">
                  <c:v>2.3800000000000002E-2</c:v>
                </c:pt>
                <c:pt idx="4">
                  <c:v>2.1300000000000006E-2</c:v>
                </c:pt>
                <c:pt idx="5">
                  <c:v>8.800000000000024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945-4476-B033-6A032B90A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77608464566929625"/>
          <c:y val="0.14751183928421926"/>
          <c:w val="0.18771969621410994"/>
          <c:h val="0.66391384602931813"/>
        </c:manualLayout>
      </c:layout>
      <c:overlay val="0"/>
      <c:txPr>
        <a:bodyPr/>
        <a:lstStyle/>
        <a:p>
          <a:pPr>
            <a:defRPr lang="en-US"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zero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FEE14-1E7C-4606-A476-E3BBB805E073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C710C-8F33-4484-AD61-0B2FA73ACB5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381000" y="457200"/>
          <a:ext cx="4800600" cy="441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4953000" y="1219200"/>
          <a:ext cx="3733800" cy="2971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828800" y="434340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324600" y="403860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95400" y="5486400"/>
            <a:ext cx="69285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Supplementary figure 3. Distribution of 789 medicinal plants across (A) different taxonomic families and (b) plant part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idbhatt12@outlook.com</cp:lastModifiedBy>
  <cp:revision>2</cp:revision>
  <dcterms:created xsi:type="dcterms:W3CDTF">2023-03-03T19:18:18Z</dcterms:created>
  <dcterms:modified xsi:type="dcterms:W3CDTF">2023-05-28T00:29:31Z</dcterms:modified>
</cp:coreProperties>
</file>